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notesMasterIdLst>
    <p:notesMasterId r:id="rId4"/>
  </p:notesMasterIdLst>
  <p:sldIdLst>
    <p:sldId id="315" r:id="rId2"/>
    <p:sldId id="316" r:id="rId3"/>
  </p:sldIdLst>
  <p:sldSz cx="6858000" cy="9906000" type="A4"/>
  <p:notesSz cx="6858000" cy="9144000"/>
  <p:defaultTextStyle>
    <a:defPPr>
      <a:defRPr lang="ja-JP"/>
    </a:defPPr>
    <a:lvl1pPr marL="0" algn="l" defTabSz="914070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1pPr>
    <a:lvl2pPr marL="457034" algn="l" defTabSz="914070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2pPr>
    <a:lvl3pPr marL="914070" algn="l" defTabSz="914070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3pPr>
    <a:lvl4pPr marL="1371106" algn="l" defTabSz="914070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4pPr>
    <a:lvl5pPr marL="1828140" algn="l" defTabSz="914070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5pPr>
    <a:lvl6pPr marL="2285176" algn="l" defTabSz="914070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6pPr>
    <a:lvl7pPr marL="2742211" algn="l" defTabSz="914070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7pPr>
    <a:lvl8pPr marL="3199246" algn="l" defTabSz="914070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8pPr>
    <a:lvl9pPr marL="3656281" algn="l" defTabSz="914070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332"/>
    <p:restoredTop sz="96018"/>
  </p:normalViewPr>
  <p:slideViewPr>
    <p:cSldViewPr snapToGrid="0" snapToObjects="1">
      <p:cViewPr varScale="1">
        <p:scale>
          <a:sx n="127" d="100"/>
          <a:sy n="127" d="100"/>
        </p:scale>
        <p:origin x="504" y="200"/>
      </p:cViewPr>
      <p:guideLst/>
    </p:cSldViewPr>
  </p:slideViewPr>
  <p:outlineViewPr>
    <p:cViewPr>
      <p:scale>
        <a:sx n="66" d="100"/>
        <a:sy n="66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291513-DB11-1B44-B10D-DC8FDB253190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85C592-1514-3E4C-B809-F9644C0724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7510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07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034" algn="l" defTabSz="91407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070" algn="l" defTabSz="91407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106" algn="l" defTabSz="91407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140" algn="l" defTabSz="91407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176" algn="l" defTabSz="91407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2211" algn="l" defTabSz="91407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199246" algn="l" defTabSz="91407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6281" algn="l" defTabSz="91407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85C592-1514-3E4C-B809-F9644C07247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6852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85C592-1514-3E4C-B809-F9644C07247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03740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5000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456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0946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007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58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16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8299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606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9535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987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349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9ABDD-EB94-2B4D-A8E0-ECE9510F1E0B}" type="datetimeFigureOut">
              <a:rPr kumimoji="1" lang="ja-JP" altLang="en-US" smtClean="0"/>
              <a:t>2019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01CA9-585D-9E44-B34D-3845B2B9C8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845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4">
            <a:extLst>
              <a:ext uri="{FF2B5EF4-FFF2-40B4-BE49-F238E27FC236}">
                <a16:creationId xmlns:a16="http://schemas.microsoft.com/office/drawing/2014/main" id="{55FC96CB-136D-9F49-A9BD-2253860D33EA}"/>
              </a:ext>
            </a:extLst>
          </p:cNvPr>
          <p:cNvSpPr txBox="1"/>
          <p:nvPr/>
        </p:nvSpPr>
        <p:spPr>
          <a:xfrm>
            <a:off x="240587" y="259901"/>
            <a:ext cx="65306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mbinations (or pairs) of genetic alterations showing co-occurrence or mutual exclusivity in KNBTG 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A629E75-F528-2C41-86F6-BF12E31789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587" y="863779"/>
            <a:ext cx="6356156" cy="399327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6501C71-B0B0-904B-B54F-E8D695773CD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4873" y="5067300"/>
            <a:ext cx="3177166" cy="123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0417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1ED61356-4BB9-074E-9685-1DDC044F1F24}"/>
              </a:ext>
            </a:extLst>
          </p:cNvPr>
          <p:cNvSpPr/>
          <p:nvPr/>
        </p:nvSpPr>
        <p:spPr>
          <a:xfrm>
            <a:off x="434885" y="576666"/>
            <a:ext cx="610481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Kaplan-Meier analysis of overall survival in Step1 between KNBTG and TCG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4866FEF-F4C3-2643-8ED9-1A93113E95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354" y="1276608"/>
            <a:ext cx="3466681" cy="2396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8364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961</TotalTime>
  <Words>34</Words>
  <Application>Microsoft Macintosh PowerPoint</Application>
  <PresentationFormat>A4 Paper (210x297 mm)</PresentationFormat>
  <Paragraphs>4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梅原徹</dc:creator>
  <cp:lastModifiedBy>梅原徹</cp:lastModifiedBy>
  <cp:revision>487</cp:revision>
  <cp:lastPrinted>2018-11-01T06:30:34Z</cp:lastPrinted>
  <dcterms:created xsi:type="dcterms:W3CDTF">2018-06-06T09:42:34Z</dcterms:created>
  <dcterms:modified xsi:type="dcterms:W3CDTF">2019-05-29T04:04:48Z</dcterms:modified>
</cp:coreProperties>
</file>